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6"/>
  </p:notesMasterIdLst>
  <p:handoutMasterIdLst>
    <p:handoutMasterId r:id="rId7"/>
  </p:handoutMasterIdLst>
  <p:sldIdLst>
    <p:sldId id="324" r:id="rId5"/>
  </p:sldIdLst>
  <p:sldSz cx="6858000" cy="9144000" type="screen4x3"/>
  <p:notesSz cx="6742113" cy="9872663"/>
  <p:defaultTextStyle>
    <a:defPPr>
      <a:defRPr lang="ja-JP"/>
    </a:defPPr>
    <a:lvl1pPr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5pPr>
    <a:lvl6pPr marL="2286000" algn="l" defTabSz="914400" rtl="0" eaLnBrk="1" latinLnBrk="0" hangingPunct="1">
      <a:defRPr kumimoji="1" sz="24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6pPr>
    <a:lvl7pPr marL="2743200" algn="l" defTabSz="914400" rtl="0" eaLnBrk="1" latinLnBrk="0" hangingPunct="1">
      <a:defRPr kumimoji="1" sz="24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7pPr>
    <a:lvl8pPr marL="3200400" algn="l" defTabSz="914400" rtl="0" eaLnBrk="1" latinLnBrk="0" hangingPunct="1">
      <a:defRPr kumimoji="1" sz="24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8pPr>
    <a:lvl9pPr marL="3657600" algn="l" defTabSz="914400" rtl="0" eaLnBrk="1" latinLnBrk="0" hangingPunct="1">
      <a:defRPr kumimoji="1" sz="24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2ED9D49F-AA6E-9F21-FC37-C929F14AF95C}" name="吳建甫" initials="吳建甫" userId="S::chienfuwu@smail.nchu.edu.tw::c5775c99-bbf3-4fcb-9699-18d78189bfea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E0511"/>
    <a:srgbClr val="3C576E"/>
    <a:srgbClr val="04AC44"/>
    <a:srgbClr val="3333FF"/>
    <a:srgbClr val="FFFFFF"/>
    <a:srgbClr val="00B050"/>
    <a:srgbClr val="BBE0E3"/>
    <a:srgbClr val="FF0080"/>
    <a:srgbClr val="333399"/>
    <a:srgbClr val="82C7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等深淺樣式 2 - 輔色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5973" autoAdjust="0"/>
    <p:restoredTop sz="95964" autoAdjust="0"/>
  </p:normalViewPr>
  <p:slideViewPr>
    <p:cSldViewPr>
      <p:cViewPr varScale="1">
        <p:scale>
          <a:sx n="83" d="100"/>
          <a:sy n="83" d="100"/>
        </p:scale>
        <p:origin x="3736" y="208"/>
      </p:cViewPr>
      <p:guideLst>
        <p:guide orient="horz" pos="2880"/>
        <p:guide pos="2160"/>
      </p:guideLst>
    </p:cSldViewPr>
  </p:slideViewPr>
  <p:outlineViewPr>
    <p:cViewPr>
      <p:scale>
        <a:sx n="50" d="100"/>
        <a:sy n="50" d="100"/>
      </p:scale>
      <p:origin x="0" y="0"/>
    </p:cViewPr>
  </p:outlineViewPr>
  <p:notesTextViewPr>
    <p:cViewPr>
      <p:scale>
        <a:sx n="150" d="100"/>
        <a:sy n="15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handoutMaster" Target="handoutMasters/handoutMaster1.xml"/><Relationship Id="rId12" Type="http://schemas.microsoft.com/office/2018/10/relationships/authors" Target="author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698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21582" cy="4936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en-US" altLang="ja-JP" dirty="0"/>
          </a:p>
        </p:txBody>
      </p:sp>
      <p:sp>
        <p:nvSpPr>
          <p:cNvPr id="29699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20531" y="0"/>
            <a:ext cx="2921582" cy="4936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endParaRPr lang="en-US" altLang="ja-JP" dirty="0"/>
          </a:p>
        </p:txBody>
      </p:sp>
      <p:sp>
        <p:nvSpPr>
          <p:cNvPr id="29700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9379030"/>
            <a:ext cx="2921582" cy="4936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en-US" altLang="ja-JP" dirty="0"/>
          </a:p>
        </p:txBody>
      </p:sp>
      <p:sp>
        <p:nvSpPr>
          <p:cNvPr id="29701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20531" y="9379030"/>
            <a:ext cx="2921582" cy="4936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F0405E8D-78BA-46CE-9351-BD3F07360713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11486382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2" name="Rectangle 1026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21582" cy="4936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en-US" altLang="ja-JP" dirty="0"/>
          </a:p>
        </p:txBody>
      </p:sp>
      <p:sp>
        <p:nvSpPr>
          <p:cNvPr id="10243" name="Rectangle 1027"/>
          <p:cNvSpPr>
            <a:spLocks noGrp="1" noChangeArrowheads="1"/>
          </p:cNvSpPr>
          <p:nvPr>
            <p:ph type="dt" idx="1"/>
          </p:nvPr>
        </p:nvSpPr>
        <p:spPr bwMode="auto">
          <a:xfrm>
            <a:off x="3820531" y="0"/>
            <a:ext cx="2921582" cy="4936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endParaRPr lang="en-US" altLang="ja-JP" dirty="0"/>
          </a:p>
        </p:txBody>
      </p:sp>
      <p:sp>
        <p:nvSpPr>
          <p:cNvPr id="10244" name="Rectangle 1028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1982788" y="739775"/>
            <a:ext cx="2776537" cy="3703638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  <a:ext uri="{53640926-AAD7-44D8-BBD7-CCE9431645EC}">
              <a14:shadowObscured xmlns:a14="http://schemas.microsoft.com/office/drawing/2010/main" val="1"/>
            </a:ext>
          </a:extLst>
        </p:spPr>
      </p:sp>
      <p:sp>
        <p:nvSpPr>
          <p:cNvPr id="10245" name="Rectangle 1029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898949" y="4689515"/>
            <a:ext cx="4944216" cy="44426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10246" name="Rectangle 1030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9379030"/>
            <a:ext cx="2921582" cy="4936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en-US" altLang="ja-JP" dirty="0"/>
          </a:p>
        </p:txBody>
      </p:sp>
      <p:sp>
        <p:nvSpPr>
          <p:cNvPr id="10247" name="Rectangle 1031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20531" y="9379030"/>
            <a:ext cx="2921582" cy="4936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D9FFBD4F-9474-4780-8DBA-462E29ED7B01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3955180454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1pPr>
    <a:lvl2pPr marL="457200" algn="l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2pPr>
    <a:lvl3pPr marL="914400" algn="l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3pPr>
    <a:lvl4pPr marL="1371600" algn="l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4pPr>
    <a:lvl5pPr marL="1828800" algn="l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E7AFA02-3A71-4EDC-B423-667874068FBD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26402660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54E27CC-85E4-4496-A7F0-2E2670B20B92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4251193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886325" y="812800"/>
            <a:ext cx="1457325" cy="7315200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514350" y="812800"/>
            <a:ext cx="4219575" cy="7315200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8CFFD98-9F5D-46B8-9754-C6A950F5FA70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34684488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6A7A8B3-9053-45B9-B735-E224EA3F700F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2321865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5FE32FF-88FC-474E-996B-A94BCDED6453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27500541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514350" y="2641600"/>
            <a:ext cx="2838450" cy="54864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505200" y="2641600"/>
            <a:ext cx="2838450" cy="54864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B555867D-8AAE-4A66-A076-18178580007B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19581189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713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9B8ACE5-1135-4BE0-B388-161C50BEDD8F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41124570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CFCAD62-6D3F-45DC-B872-ADA7E085D823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4903557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B0ACF794-06F2-4293-9454-C61DD4CFF7E0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23422261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5132D4C-4246-4204-BA16-7119E5B05E5B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21601571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9D310D11-78E9-40A8-AAC3-BBB7F94918BA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31395410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514350" y="812800"/>
            <a:ext cx="58293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タイトルの書式設定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514350" y="2641600"/>
            <a:ext cx="5829300" cy="5486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514350" y="8331200"/>
            <a:ext cx="1428750" cy="609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endParaRPr lang="en-US" altLang="ja-JP" dirty="0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31200"/>
            <a:ext cx="2171700" cy="609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endParaRPr lang="en-US" altLang="ja-JP" dirty="0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31200"/>
            <a:ext cx="1428750" cy="609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fld id="{2E051F03-9376-418F-B588-D0E7AFEFCA51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80" charset="-128"/>
        </a:defRPr>
      </a:lvl2pPr>
      <a:lvl3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80" charset="-128"/>
        </a:defRPr>
      </a:lvl3pPr>
      <a:lvl4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80" charset="-128"/>
        </a:defRPr>
      </a:lvl4pPr>
      <a:lvl5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80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80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80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80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80" charset="-128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Char char="•"/>
        <a:defRPr kumimoji="1"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Char char="–"/>
        <a:defRPr kumimoji="1" sz="2800">
          <a:solidFill>
            <a:schemeClr val="tx1"/>
          </a:solidFill>
          <a:latin typeface="+mn-lt"/>
          <a:ea typeface="+mn-ea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Char char="•"/>
        <a:defRPr kumimoji="1" sz="2400">
          <a:solidFill>
            <a:schemeClr val="tx1"/>
          </a:solidFill>
          <a:latin typeface="+mn-lt"/>
          <a:ea typeface="+mn-ea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Char char="–"/>
        <a:defRPr kumimoji="1" sz="2000">
          <a:solidFill>
            <a:schemeClr val="tx1"/>
          </a:solidFill>
          <a:latin typeface="+mn-lt"/>
          <a:ea typeface="+mn-ea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7A55C0AE-B506-0F19-9678-92A75B73150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45088536"/>
              </p:ext>
            </p:extLst>
          </p:nvPr>
        </p:nvGraphicFramePr>
        <p:xfrm>
          <a:off x="154469" y="28587"/>
          <a:ext cx="6549062" cy="9086825"/>
        </p:xfrm>
        <a:graphic>
          <a:graphicData uri="http://schemas.openxmlformats.org/drawingml/2006/table">
            <a:tbl>
              <a:tblPr/>
              <a:tblGrid>
                <a:gridCol w="3381156">
                  <a:extLst>
                    <a:ext uri="{9D8B030D-6E8A-4147-A177-3AD203B41FA5}">
                      <a16:colId xmlns:a16="http://schemas.microsoft.com/office/drawing/2014/main" val="2486912787"/>
                    </a:ext>
                  </a:extLst>
                </a:gridCol>
                <a:gridCol w="1035393">
                  <a:extLst>
                    <a:ext uri="{9D8B030D-6E8A-4147-A177-3AD203B41FA5}">
                      <a16:colId xmlns:a16="http://schemas.microsoft.com/office/drawing/2014/main" val="2290774495"/>
                    </a:ext>
                  </a:extLst>
                </a:gridCol>
                <a:gridCol w="1445058">
                  <a:extLst>
                    <a:ext uri="{9D8B030D-6E8A-4147-A177-3AD203B41FA5}">
                      <a16:colId xmlns:a16="http://schemas.microsoft.com/office/drawing/2014/main" val="956608392"/>
                    </a:ext>
                  </a:extLst>
                </a:gridCol>
                <a:gridCol w="687455">
                  <a:extLst>
                    <a:ext uri="{9D8B030D-6E8A-4147-A177-3AD203B41FA5}">
                      <a16:colId xmlns:a16="http://schemas.microsoft.com/office/drawing/2014/main" val="806153662"/>
                    </a:ext>
                  </a:extLst>
                </a:gridCol>
              </a:tblGrid>
              <a:tr h="368987"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新細明體" panose="02020500000000000000" pitchFamily="18" charset="-120"/>
                        </a:rPr>
                        <a:t>Supplementary Table S1.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新細明體" panose="02020500000000000000" pitchFamily="18" charset="-120"/>
                        </a:rPr>
                        <a:t> List of the amino acid sequences of replicases </a:t>
                      </a:r>
                      <a:b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新細明體" panose="02020500000000000000" pitchFamily="18" charset="-120"/>
                        </a:rPr>
                      </a:b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新細明體" panose="02020500000000000000" pitchFamily="18" charset="-120"/>
                        </a:rPr>
                        <a:t>used in the phylogenetic analyses of this study. 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>
                    <a:lnL w="12700" cmpd="sng">
                      <a:noFill/>
                      <a:prstDash val="solid"/>
                    </a:lnL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zh-TW" alt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　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99906935"/>
                  </a:ext>
                </a:extLst>
              </a:tr>
              <a:tr h="31591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Virus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Abbreviation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Replicase </a:t>
                      </a:r>
                      <a:b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</a:b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accession No.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Host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54436518"/>
                  </a:ext>
                </a:extLst>
              </a:tr>
              <a:tr h="155713"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000" b="1" i="1" u="none" strike="noStrike" dirty="0" err="1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Alphaflexiviridae</a:t>
                      </a:r>
                      <a:endParaRPr lang="en-US" sz="1000" b="1" i="1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  <a:ea typeface="新細明體" panose="02020500000000000000" pitchFamily="18" charset="-120"/>
                      </a:endParaRP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>
                    <a:lnL w="12700" cmpd="sng">
                      <a:noFill/>
                      <a:prstDash val="solid"/>
                    </a:lnL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zh-TW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　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04449680"/>
                  </a:ext>
                </a:extLst>
              </a:tr>
              <a:tr h="15571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Lolium latent virus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LoLV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YP_001718499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Plant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78262379"/>
                  </a:ext>
                </a:extLst>
              </a:tr>
              <a:tr h="15571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Potato virus X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PVX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YP_002332929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Plant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16823142"/>
                  </a:ext>
                </a:extLst>
              </a:tr>
              <a:tr h="15571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Shallot virus X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ShVX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NP_620648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Plant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2230231"/>
                  </a:ext>
                </a:extLst>
              </a:tr>
              <a:tr h="15571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Botrytis virus X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BotV-X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NP_932306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Fungus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60415467"/>
                  </a:ext>
                </a:extLst>
              </a:tr>
              <a:tr h="30805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Sclerotinia </a:t>
                      </a:r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sclerotiorum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 </a:t>
                      </a:r>
                      <a:b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</a:b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debilitation-associated RNA virus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SsDRV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YP_325662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Fungus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18910082"/>
                  </a:ext>
                </a:extLst>
              </a:tr>
              <a:tr h="15571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Donkey orchid symptomless virus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DOSV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YP_008828152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Plant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70737770"/>
                  </a:ext>
                </a:extLst>
              </a:tr>
              <a:tr h="155713"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000" b="1" i="1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Betaflexiviridae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>
                    <a:lnL w="12700" cmpd="sng">
                      <a:noFill/>
                      <a:prstDash val="solid"/>
                    </a:lnL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zh-TW" altLang="en-US" sz="10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  <a:ea typeface="新細明體" panose="02020500000000000000" pitchFamily="18" charset="-120"/>
                      </a:endParaRP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60317319"/>
                  </a:ext>
                </a:extLst>
              </a:tr>
              <a:tr h="15571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Carnation latent virus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CLV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QJX15400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Plant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62950385"/>
                  </a:ext>
                </a:extLst>
              </a:tr>
              <a:tr h="15571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Apple stem pitting virus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ASPV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NP_604464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Plant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05759269"/>
                  </a:ext>
                </a:extLst>
              </a:tr>
              <a:tr h="15571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Cherry necrotic rusty mottle virus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CNRMV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NP_059937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Plant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56129505"/>
                  </a:ext>
                </a:extLst>
              </a:tr>
              <a:tr h="15571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Potato virus T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PVT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YP_002019748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Plant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93443394"/>
                  </a:ext>
                </a:extLst>
              </a:tr>
              <a:tr h="15571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Grapevine virus A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GVA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NP_619662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Plant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42835249"/>
                  </a:ext>
                </a:extLst>
              </a:tr>
              <a:tr h="15571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Citrus leaf blotch virus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CLBV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NP_624333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Plant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27132456"/>
                  </a:ext>
                </a:extLst>
              </a:tr>
              <a:tr h="15571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Apricot vein clearing associated virus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AVCaV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YP_008997790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Plant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60912779"/>
                  </a:ext>
                </a:extLst>
              </a:tr>
              <a:tr h="15571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Watermelon virus A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WVA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YP_009357235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Plant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82447419"/>
                  </a:ext>
                </a:extLst>
              </a:tr>
              <a:tr h="15571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Apple chlorotic leaf spot virus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ACLSV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NP_040551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Plant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33795848"/>
                  </a:ext>
                </a:extLst>
              </a:tr>
              <a:tr h="15571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Carrot Ch virus 1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CChV-1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YP_009103999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Plant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26821536"/>
                  </a:ext>
                </a:extLst>
              </a:tr>
              <a:tr h="15571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Ribes americanum virus A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RAVA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YP_009553496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Plant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38658163"/>
                  </a:ext>
                </a:extLst>
              </a:tr>
              <a:tr h="155713"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000" b="1" i="1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Gammaflexiviridae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>
                    <a:lnL w="12700" cmpd="sng">
                      <a:noFill/>
                      <a:prstDash val="solid"/>
                    </a:lnL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TW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　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57701957"/>
                  </a:ext>
                </a:extLst>
              </a:tr>
              <a:tr h="15571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Botrytis virus F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BotV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-F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NP_068549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Fungus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19842971"/>
                  </a:ext>
                </a:extLst>
              </a:tr>
              <a:tr h="15571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Entoleuca gammaflexivirus 1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EnGFV1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AVD68667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Fungus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06483490"/>
                  </a:ext>
                </a:extLst>
              </a:tr>
              <a:tr h="15571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Entoleuca gammaflexivirus 2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EnGFV2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AVD68668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Fungus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24183307"/>
                  </a:ext>
                </a:extLst>
              </a:tr>
              <a:tr h="15571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Pistacia-associated flexivirus 1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PAFV1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QDO72745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Plant*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26436446"/>
                  </a:ext>
                </a:extLst>
              </a:tr>
              <a:tr h="155713"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000" b="1" i="1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Tymoviridae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>
                    <a:lnL w="12700" cmpd="sng">
                      <a:noFill/>
                      <a:prstDash val="solid"/>
                    </a:lnL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TW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　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98804090"/>
                  </a:ext>
                </a:extLst>
              </a:tr>
              <a:tr h="15571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Turnip yellow mosaic virus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TYMV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NP_663297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Plant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07299224"/>
                  </a:ext>
                </a:extLst>
              </a:tr>
              <a:tr h="15571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Maize rayado fino virus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MRFV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NP_115454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Plant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6003189"/>
                  </a:ext>
                </a:extLst>
              </a:tr>
              <a:tr h="15571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222222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Grapevine fleck virus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GFKV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NP_542612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Plant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83869933"/>
                  </a:ext>
                </a:extLst>
              </a:tr>
              <a:tr h="30805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Sclerotinia sclerotiorum </a:t>
                      </a:r>
                      <a:b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</a:b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tymo-like RNA virus 4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SsTLRV4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AWY10995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Fungus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74111098"/>
                  </a:ext>
                </a:extLst>
              </a:tr>
              <a:tr h="15571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Botrytis cinerea mycotymovirus 1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BcMTV1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QJQ28892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Fungus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32313949"/>
                  </a:ext>
                </a:extLst>
              </a:tr>
              <a:tr h="15571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Sclerotinia sclerotiorum mycotymovirus 1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SsMTV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QDF82047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Fungus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07359961"/>
                  </a:ext>
                </a:extLst>
              </a:tr>
              <a:tr h="155713"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000" b="1" i="1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Deltaflexiviridae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>
                    <a:lnL w="12700" cmpd="sng">
                      <a:noFill/>
                      <a:prstDash val="solid"/>
                    </a:lnL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TW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　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0307786"/>
                  </a:ext>
                </a:extLst>
              </a:tr>
              <a:tr h="15571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Soybean leaf-associated mycoflexivirus 1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SlaMV1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YP_009508374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Plant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43534942"/>
                  </a:ext>
                </a:extLst>
              </a:tr>
              <a:tr h="15571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Erysiphe necator associated deltaflexivirus 1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EnaDFV1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QKN22722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Fungus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02854233"/>
                  </a:ext>
                </a:extLst>
              </a:tr>
              <a:tr h="15571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Erysiphe necator associated deltaflexivirus 2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EnaDFV2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QKN22647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Fungus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4638726"/>
                  </a:ext>
                </a:extLst>
              </a:tr>
              <a:tr h="15571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Erysiphe necator associated deltaflexivirus 3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EnaDFV3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QKN22684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Fungus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60674803"/>
                  </a:ext>
                </a:extLst>
              </a:tr>
              <a:tr h="15571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Erysiphe necator associated deltaflexivirus 4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EnaDFV4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QKN22695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Fungus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44522784"/>
                  </a:ext>
                </a:extLst>
              </a:tr>
              <a:tr h="15571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Sclerotinia sclerotiorum deltaflexivirus 1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SsDFV1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YP_009508363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Fungus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90569378"/>
                  </a:ext>
                </a:extLst>
              </a:tr>
              <a:tr h="15571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Alternaria alternata deltaflexivirus 1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AaDFV1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QTZ98076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Fungus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7110528"/>
                  </a:ext>
                </a:extLst>
              </a:tr>
              <a:tr h="15571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Agrostis stolonifera deltaflexivirus 1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AsDFV1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QQG34628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Plant**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56047087"/>
                  </a:ext>
                </a:extLst>
              </a:tr>
              <a:tr h="15571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Sesame deltaflexivirus 1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SDFV1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QQG34641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Plant*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37925380"/>
                  </a:ext>
                </a:extLst>
              </a:tr>
              <a:tr h="15571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Fusarium graminearum deltaflexivirus 1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FgDFV1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YP_009268710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Fungus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79761701"/>
                  </a:ext>
                </a:extLst>
              </a:tr>
              <a:tr h="15571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Agave tequilana deltaflexivirus 1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AtDFV1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QQG34632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Plant*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14462112"/>
                  </a:ext>
                </a:extLst>
              </a:tr>
              <a:tr h="15571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Botrytis cinerea deltaflexivirus 1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BcDFV1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QJT73731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Fungus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99726468"/>
                  </a:ext>
                </a:extLst>
              </a:tr>
              <a:tr h="15571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Sclerotinia sclerotiorum deltaflexivirus 2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SsDFV2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YP_009552771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Fungus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17376120"/>
                  </a:ext>
                </a:extLst>
              </a:tr>
              <a:tr h="15571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Sclerotinia sclerotiorum deltaflexivirus 3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SsDFV3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UOJ41056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Fungus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96862487"/>
                  </a:ext>
                </a:extLst>
              </a:tr>
              <a:tr h="15571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Pleurotus ostreatus deltaflexivirus 1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PoDFV1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WCU24521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Fungus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28885466"/>
                  </a:ext>
                </a:extLst>
              </a:tr>
              <a:tr h="15571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Calypogeia fissa associated deltaflexivirus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CfaDFV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CAH2618741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Plant*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73135642"/>
                  </a:ext>
                </a:extLst>
              </a:tr>
              <a:tr h="15571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Aspergillus flavus deltaflexivirus 1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AfDFV1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UAW09565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Fungus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21785919"/>
                  </a:ext>
                </a:extLst>
              </a:tr>
              <a:tr h="15571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Lentinula edodes deltaflexivirus 1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LeDFV1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QOX06047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j-lt"/>
                          <a:ea typeface="新細明體" panose="02020500000000000000" pitchFamily="18" charset="-120"/>
                        </a:rPr>
                        <a:t>Fungus</a:t>
                      </a: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98342148"/>
                  </a:ext>
                </a:extLst>
              </a:tr>
              <a:tr h="155713"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-US" altLang="zh-TW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*: This virus was discovered from metagenomic data of plant tissues with potential fungal infection.</a:t>
                      </a:r>
                    </a:p>
                    <a:p>
                      <a:pPr algn="l" fontAlgn="ctr"/>
                      <a:r>
                        <a:rPr lang="en-US" altLang="zh-TW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**: This virus was detected from plant tissues and sequence was determined using Sanger sequencing. </a:t>
                      </a:r>
                      <a:endParaRPr lang="zh-TW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zh-TW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  <a:ea typeface="新細明體" panose="02020500000000000000" pitchFamily="18" charset="-120"/>
                      </a:endParaRP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zh-TW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  <a:ea typeface="新細明體" panose="02020500000000000000" pitchFamily="18" charset="-120"/>
                      </a:endParaRP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zh-TW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  <a:ea typeface="新細明體" panose="02020500000000000000" pitchFamily="18" charset="-120"/>
                      </a:endParaRPr>
                    </a:p>
                  </a:txBody>
                  <a:tcPr marL="3376" marR="3376" marT="337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1789340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710894432"/>
      </p:ext>
    </p:extLst>
  </p:cSld>
  <p:clrMapOvr>
    <a:masterClrMapping/>
  </p:clrMapOvr>
</p:sld>
</file>

<file path=ppt/theme/theme1.xml><?xml version="1.0" encoding="utf-8"?>
<a:theme xmlns:a="http://schemas.openxmlformats.org/drawingml/2006/main" name="新しいプレゼンテーション">
  <a:themeElements>
    <a:clrScheme name="新しいプレゼンテーション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新しいプレゼンテーション">
      <a:majorFont>
        <a:latin typeface="Arial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新しいプレゼンテーション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713E39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BBAFAE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​​テーマ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​​テーマ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48771fd5-fdbd-41d5-a635-61c877e51ed8" xsi:nil="true"/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文件" ma:contentTypeID="0x0101007E2FD972D4BEA54BA4598308043A68E5" ma:contentTypeVersion="15" ma:contentTypeDescription="建立新的文件。" ma:contentTypeScope="" ma:versionID="a8220bdea2b7e7a673e49e11bde4d37a">
  <xsd:schema xmlns:xsd="http://www.w3.org/2001/XMLSchema" xmlns:xs="http://www.w3.org/2001/XMLSchema" xmlns:p="http://schemas.microsoft.com/office/2006/metadata/properties" xmlns:ns3="48771fd5-fdbd-41d5-a635-61c877e51ed8" targetNamespace="http://schemas.microsoft.com/office/2006/metadata/properties" ma:root="true" ma:fieldsID="43f6d274064a590dd4c7dc18eb5ad241" ns3:_="">
    <xsd:import namespace="48771fd5-fdbd-41d5-a635-61c877e51ed8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DateTaken" minOccurs="0"/>
                <xsd:element ref="ns3:MediaLengthInSeconds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Location" minOccurs="0"/>
                <xsd:element ref="ns3:_activity" minOccurs="0"/>
                <xsd:element ref="ns3:MediaServiceObjectDetectorVersions" minOccurs="0"/>
                <xsd:element ref="ns3:MediaServiceSystemTags" minOccurs="0"/>
                <xsd:element ref="ns3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8771fd5-fdbd-41d5-a635-61c877e51ed8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3" nillable="true" ma:displayName="MediaLengthInSeconds" ma:hidden="true" ma:internalName="MediaLengthInSeconds" ma:readOnly="true">
      <xsd:simpleType>
        <xsd:restriction base="dms:Unknown"/>
      </xsd:simpleType>
    </xsd:element>
    <xsd:element name="MediaServiceAutoTags" ma:index="14" nillable="true" ma:displayName="Tags" ma:internalName="MediaServiceAutoTags" ma:readOnly="true">
      <xsd:simpleType>
        <xsd:restriction base="dms:Text"/>
      </xsd:simple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Location" ma:index="18" nillable="true" ma:displayName="Location" ma:internalName="MediaServiceLocation" ma:readOnly="true">
      <xsd:simpleType>
        <xsd:restriction base="dms:Text"/>
      </xsd:simpleType>
    </xsd:element>
    <xsd:element name="_activity" ma:index="19" nillable="true" ma:displayName="_activity" ma:hidden="true" ma:internalName="_activity">
      <xsd:simpleType>
        <xsd:restriction base="dms:Note"/>
      </xsd:simpleType>
    </xsd:element>
    <xsd:element name="MediaServiceObjectDetectorVersions" ma:index="20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ystemTags" ma:index="21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SearchProperties" ma:index="22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內容類型"/>
        <xsd:element ref="dc:title" minOccurs="0" maxOccurs="1" ma:index="4" ma:displayName="標題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70A4D93D-CB7A-4046-B8F0-734EB4DA984F}">
  <ds:schemaRefs>
    <ds:schemaRef ds:uri="http://schemas.openxmlformats.org/package/2006/metadata/core-properties"/>
    <ds:schemaRef ds:uri="http://purl.org/dc/elements/1.1/"/>
    <ds:schemaRef ds:uri="http://purl.org/dc/terms/"/>
    <ds:schemaRef ds:uri="http://schemas.microsoft.com/office/2006/metadata/properties"/>
    <ds:schemaRef ds:uri="http://schemas.microsoft.com/office/2006/documentManagement/types"/>
    <ds:schemaRef ds:uri="http://purl.org/dc/dcmitype/"/>
    <ds:schemaRef ds:uri="http://schemas.microsoft.com/office/infopath/2007/PartnerControls"/>
    <ds:schemaRef ds:uri="48771fd5-fdbd-41d5-a635-61c877e51ed8"/>
    <ds:schemaRef ds:uri="http://www.w3.org/XML/1998/namespace"/>
  </ds:schemaRefs>
</ds:datastoreItem>
</file>

<file path=customXml/itemProps2.xml><?xml version="1.0" encoding="utf-8"?>
<ds:datastoreItem xmlns:ds="http://schemas.openxmlformats.org/officeDocument/2006/customXml" ds:itemID="{07D4AA48-083E-4379-89A1-F75D79A20FC0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48771fd5-fdbd-41d5-a635-61c877e51ed8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FBB41457-EEA7-4D1C-80C7-C64600237B15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03458</TotalTime>
  <Words>438</Words>
  <Application>Microsoft Macintosh PowerPoint</Application>
  <PresentationFormat>画面に合わせる (4:3)</PresentationFormat>
  <Paragraphs>19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2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4" baseType="lpstr">
      <vt:lpstr>Arial</vt:lpstr>
      <vt:lpstr>Times New Roman</vt:lpstr>
      <vt:lpstr>新しいプレゼンテーション</vt:lpstr>
      <vt:lpstr>PowerPoint プレゼンテーション</vt:lpstr>
    </vt:vector>
  </TitlesOfParts>
  <Company>青木 菜々子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template</dc:title>
  <dc:creator>Chien-Fu Wu</dc:creator>
  <cp:lastModifiedBy>KOMATSU Ken</cp:lastModifiedBy>
  <cp:revision>1150</cp:revision>
  <cp:lastPrinted>2021-04-12T04:03:22Z</cp:lastPrinted>
  <dcterms:created xsi:type="dcterms:W3CDTF">2010-08-07T07:11:10Z</dcterms:created>
  <dcterms:modified xsi:type="dcterms:W3CDTF">2024-10-29T08:15:1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7E2FD972D4BEA54BA4598308043A68E5</vt:lpwstr>
  </property>
</Properties>
</file>